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3_&#49692;&#52380;&#45824;&#54617;&#44368;\&#49892;&#54744;%20data\&#52628;&#52636;&#47932;&amp;compounds\&#51060;&#49457;&#53468;%20&#44368;&#49688;&#45784;\TSG\cck,%20activity\2017_10_30_TSG_o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21:$H$21</c:f>
                <c:numCache>
                  <c:formatCode>General</c:formatCode>
                  <c:ptCount val="6"/>
                  <c:pt idx="0">
                    <c:v>3.0210373011702707</c:v>
                  </c:pt>
                  <c:pt idx="1">
                    <c:v>1.9120140263112275</c:v>
                  </c:pt>
                  <c:pt idx="2">
                    <c:v>1.7241373372419642</c:v>
                  </c:pt>
                  <c:pt idx="3">
                    <c:v>2.8968244236795737</c:v>
                  </c:pt>
                  <c:pt idx="4">
                    <c:v>2.586274820757223</c:v>
                  </c:pt>
                  <c:pt idx="5">
                    <c:v>1.631621791947429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C$15:$H$15</c:f>
              <c:numCache>
                <c:formatCode>General</c:formatCode>
                <c:ptCount val="6"/>
              </c:numCache>
            </c:numRef>
          </c:cat>
          <c:val>
            <c:numRef>
              <c:f>Sheet2!$C$20:$H$20</c:f>
              <c:numCache>
                <c:formatCode>0</c:formatCode>
                <c:ptCount val="6"/>
                <c:pt idx="0" formatCode="General">
                  <c:v>74.999999999999986</c:v>
                </c:pt>
                <c:pt idx="1">
                  <c:v>78.072408032636972</c:v>
                </c:pt>
                <c:pt idx="2">
                  <c:v>79.277715059435877</c:v>
                </c:pt>
                <c:pt idx="3">
                  <c:v>75.320338327354548</c:v>
                </c:pt>
                <c:pt idx="4">
                  <c:v>81.514225926707454</c:v>
                </c:pt>
                <c:pt idx="5">
                  <c:v>86.5103397341211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9230520"/>
        <c:axId val="349230912"/>
      </c:barChart>
      <c:catAx>
        <c:axId val="349230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49230912"/>
        <c:crosses val="autoZero"/>
        <c:auto val="1"/>
        <c:lblAlgn val="ctr"/>
        <c:lblOffset val="100"/>
        <c:noMultiLvlLbl val="0"/>
      </c:catAx>
      <c:valAx>
        <c:axId val="34923091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49230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Sheet1!$J$8:$P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8804606395386485E-2</c:v>
                  </c:pt>
                  <c:pt idx="2">
                    <c:v>8.6896535425956423E-3</c:v>
                  </c:pt>
                  <c:pt idx="3">
                    <c:v>1.4955585290310134E-2</c:v>
                  </c:pt>
                  <c:pt idx="4">
                    <c:v>1.3532287058066641E-2</c:v>
                  </c:pt>
                  <c:pt idx="5">
                    <c:v>6.8068689591352441E-3</c:v>
                  </c:pt>
                  <c:pt idx="6">
                    <c:v>1.1863049327284575E-2</c:v>
                  </c:pt>
                </c:numCache>
              </c:numRef>
            </c:plus>
            <c:minus>
              <c:numRef>
                <c:f>Sheet1!$J$8:$P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8804606395386485E-2</c:v>
                  </c:pt>
                  <c:pt idx="2">
                    <c:v>8.6896535425956423E-3</c:v>
                  </c:pt>
                  <c:pt idx="3">
                    <c:v>1.4955585290310134E-2</c:v>
                  </c:pt>
                  <c:pt idx="4">
                    <c:v>1.3532287058066641E-2</c:v>
                  </c:pt>
                  <c:pt idx="5">
                    <c:v>6.8068689591352441E-3</c:v>
                  </c:pt>
                  <c:pt idx="6">
                    <c:v>1.18630493272845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K$3:$P$3</c:f>
              <c:numCache>
                <c:formatCode>General</c:formatCode>
                <c:ptCount val="6"/>
                <c:pt idx="0">
                  <c:v>0</c:v>
                </c:pt>
                <c:pt idx="1">
                  <c:v>0.3</c:v>
                </c:pt>
                <c:pt idx="2">
                  <c:v>1</c:v>
                </c:pt>
                <c:pt idx="3">
                  <c:v>3</c:v>
                </c:pt>
                <c:pt idx="4">
                  <c:v>10</c:v>
                </c:pt>
                <c:pt idx="5">
                  <c:v>30</c:v>
                </c:pt>
              </c:numCache>
            </c:numRef>
          </c:cat>
          <c:val>
            <c:numRef>
              <c:f>Sheet1!$K$7:$P$7</c:f>
              <c:numCache>
                <c:formatCode>General</c:formatCode>
                <c:ptCount val="6"/>
                <c:pt idx="0">
                  <c:v>0.62400891711707918</c:v>
                </c:pt>
                <c:pt idx="1">
                  <c:v>0.66040094909282077</c:v>
                </c:pt>
                <c:pt idx="2">
                  <c:v>0.66454062262718294</c:v>
                </c:pt>
                <c:pt idx="3">
                  <c:v>0.65704829727015424</c:v>
                </c:pt>
                <c:pt idx="4">
                  <c:v>0.58902612345523819</c:v>
                </c:pt>
                <c:pt idx="5">
                  <c:v>0.527386089146726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49759072"/>
        <c:axId val="349763384"/>
      </c:barChart>
      <c:catAx>
        <c:axId val="34975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349763384"/>
        <c:crosses val="autoZero"/>
        <c:auto val="1"/>
        <c:lblAlgn val="ctr"/>
        <c:lblOffset val="100"/>
        <c:noMultiLvlLbl val="0"/>
      </c:catAx>
      <c:valAx>
        <c:axId val="349763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altLang="ko-KR" sz="7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P positive</a:t>
                </a:r>
                <a:r>
                  <a:rPr lang="en-US" altLang="ko-KR" sz="700" baseline="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7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 (% area)</a:t>
                </a:r>
                <a:endParaRPr lang="ko-KR" altLang="en-US" sz="7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14744377175598E-2"/>
              <c:y val="8.432594489446490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34975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BAF3E1-3CD6-4435-8BCA-3941F797D1E7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CC95ED-3B9E-4CD2-96FB-3E0073AC303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1250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2189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4915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5061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3693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5313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4535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0907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5634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926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2964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0072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11EF52-D62B-4A2E-A8BF-C49122574049}" type="datetimeFigureOut">
              <a:rPr lang="ko-KR" altLang="en-US" smtClean="0"/>
              <a:t>2018-08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95E01-051D-46F9-82D7-66D7F050D77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1115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chart" Target="../charts/chart2.xml"/><Relationship Id="rId4" Type="http://schemas.openxmlformats.org/officeDocument/2006/relationships/image" Target="../media/image3.jpeg"/><Relationship Id="rId9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5080940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0.3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740152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3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51334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210519" y="1717942"/>
            <a:ext cx="17734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TSG</a:t>
            </a:r>
            <a:r>
              <a:rPr lang="ko-KR" altLang="en-US" sz="9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l-GR" altLang="ko-KR" sz="9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M)</a:t>
            </a:r>
            <a:endParaRPr lang="ko-KR" altLang="en-US" sz="900" dirty="0"/>
          </a:p>
        </p:txBody>
      </p:sp>
      <p:sp>
        <p:nvSpPr>
          <p:cNvPr id="33" name="TextBox 32"/>
          <p:cNvSpPr txBox="1"/>
          <p:nvPr/>
        </p:nvSpPr>
        <p:spPr>
          <a:xfrm>
            <a:off x="8399366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3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21728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>
            <a:off x="3243324" y="1948774"/>
            <a:ext cx="57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3225954" y="147301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A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910546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7569758" y="19527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079701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738913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250095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188732" y="3022323"/>
            <a:ext cx="17734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RANKL</a:t>
            </a:r>
            <a:r>
              <a:rPr lang="ko-KR" altLang="en-US" sz="9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10 ng/ml)</a:t>
            </a:r>
            <a:endParaRPr lang="ko-KR" altLang="en-US" sz="900" dirty="0"/>
          </a:p>
        </p:txBody>
      </p:sp>
      <p:sp>
        <p:nvSpPr>
          <p:cNvPr id="25" name="TextBox 24"/>
          <p:cNvSpPr txBox="1"/>
          <p:nvPr/>
        </p:nvSpPr>
        <p:spPr>
          <a:xfrm>
            <a:off x="8398127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20489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-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7" name="직선 연결선 26"/>
          <p:cNvCxnSpPr/>
          <p:nvPr/>
        </p:nvCxnSpPr>
        <p:spPr>
          <a:xfrm>
            <a:off x="3221537" y="3012049"/>
            <a:ext cx="57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5909307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568519" y="278121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+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6124873" y="4185191"/>
            <a:ext cx="8640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(%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928839" y="4919617"/>
            <a:ext cx="15841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TSG</a:t>
            </a:r>
            <a:r>
              <a:rPr lang="ko-KR" altLang="en-US" sz="9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l-GR" altLang="ko-KR" sz="9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M)</a:t>
            </a:r>
            <a:endParaRPr lang="ko-KR" altLang="en-US" sz="900" dirty="0"/>
          </a:p>
        </p:txBody>
      </p:sp>
      <p:sp>
        <p:nvSpPr>
          <p:cNvPr id="41" name="TextBox 40"/>
          <p:cNvSpPr txBox="1"/>
          <p:nvPr/>
        </p:nvSpPr>
        <p:spPr>
          <a:xfrm>
            <a:off x="3639911" y="3449658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2" name="그림 4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3050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그림 4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2656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그림 4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2262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1868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그림 4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1474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1080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0688" y="2189139"/>
            <a:ext cx="764444" cy="576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46" name="차트 45"/>
          <p:cNvGraphicFramePr>
            <a:graphicFrameLocks/>
          </p:cNvGraphicFramePr>
          <p:nvPr>
            <p:extLst/>
          </p:nvPr>
        </p:nvGraphicFramePr>
        <p:xfrm>
          <a:off x="6588561" y="3689381"/>
          <a:ext cx="2057400" cy="1257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50" name="TextBox 49"/>
          <p:cNvSpPr txBox="1"/>
          <p:nvPr/>
        </p:nvSpPr>
        <p:spPr>
          <a:xfrm>
            <a:off x="7132704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0.3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655050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3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6875620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184894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3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397624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1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927006" y="4798803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1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56" name="차트 5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2870014"/>
              </p:ext>
            </p:extLst>
          </p:nvPr>
        </p:nvGraphicFramePr>
        <p:xfrm>
          <a:off x="3593014" y="3617126"/>
          <a:ext cx="2301379" cy="1458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57" name="TextBox 41"/>
          <p:cNvSpPr txBox="1"/>
          <p:nvPr/>
        </p:nvSpPr>
        <p:spPr>
          <a:xfrm>
            <a:off x="4179301" y="3845684"/>
            <a:ext cx="1774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41"/>
          <p:cNvSpPr txBox="1"/>
          <p:nvPr/>
        </p:nvSpPr>
        <p:spPr>
          <a:xfrm>
            <a:off x="4443639" y="3754283"/>
            <a:ext cx="1774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41"/>
          <p:cNvSpPr txBox="1"/>
          <p:nvPr/>
        </p:nvSpPr>
        <p:spPr>
          <a:xfrm>
            <a:off x="4709975" y="3766394"/>
            <a:ext cx="1774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41"/>
          <p:cNvSpPr txBox="1"/>
          <p:nvPr/>
        </p:nvSpPr>
        <p:spPr>
          <a:xfrm>
            <a:off x="4974905" y="3766394"/>
            <a:ext cx="1774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41"/>
          <p:cNvSpPr txBox="1"/>
          <p:nvPr/>
        </p:nvSpPr>
        <p:spPr>
          <a:xfrm>
            <a:off x="5243785" y="3864958"/>
            <a:ext cx="1774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41"/>
          <p:cNvSpPr txBox="1"/>
          <p:nvPr/>
        </p:nvSpPr>
        <p:spPr>
          <a:xfrm>
            <a:off x="5509266" y="3944249"/>
            <a:ext cx="17745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420895" y="3456257"/>
            <a:ext cx="387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C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216987" y="4943834"/>
            <a:ext cx="15841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TSG</a:t>
            </a:r>
            <a:r>
              <a:rPr lang="ko-KR" altLang="en-US" sz="9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l-GR" altLang="ko-KR" sz="9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ko-KR" sz="900" dirty="0">
                <a:latin typeface="Times New Roman" pitchFamily="18" charset="0"/>
                <a:cs typeface="Times New Roman" pitchFamily="18" charset="0"/>
              </a:rPr>
              <a:t>M)</a:t>
            </a:r>
            <a:endParaRPr lang="ko-KR" altLang="en-US" sz="900" dirty="0"/>
          </a:p>
        </p:txBody>
      </p:sp>
      <p:sp>
        <p:nvSpPr>
          <p:cNvPr id="2" name="직사각형 1"/>
          <p:cNvSpPr/>
          <p:nvPr/>
        </p:nvSpPr>
        <p:spPr>
          <a:xfrm>
            <a:off x="2024458" y="5262163"/>
            <a:ext cx="8510954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1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TSG suppresses </a:t>
            </a:r>
            <a:r>
              <a:rPr lang="en-US" altLang="ko-KR" sz="1100" b="1" kern="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teoclastogenesis</a:t>
            </a:r>
            <a:r>
              <a:rPr lang="en-US" altLang="ko-KR" sz="1100" b="1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A) BMMs prepared from bone marrow cells were cultured for 4 days with RANKL (10 ng/mL) and M-CSF (30 ng/mL) in the presence of the indicated concentrations of TSG or 0.1% DMSO (control vehicle).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The cells were fixed in 3.7% formalin, </a:t>
            </a:r>
            <a:r>
              <a:rPr lang="en-US" altLang="ko-KR" sz="11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permeabilized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in 0.1% Triton X-100, and stained for TRAP, a marker enzyme of osteoclasts;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US" altLang="ko-KR" sz="11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TRAP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positive cells was analyzed using the Image J program</a:t>
            </a:r>
            <a:r>
              <a:rPr lang="en-US" altLang="ko-KR" sz="11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. 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ko-KR" sz="1100" kern="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100" kern="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ffect of TSG on the viability of BMMs was evaluated by CCK-8 assay.</a:t>
            </a:r>
            <a:r>
              <a:rPr lang="en-US" altLang="ko-KR" sz="11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</a:t>
            </a:r>
            <a:r>
              <a:rPr lang="en-US" altLang="ko-KR" sz="1100" kern="100" baseline="300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a,b,c,d</a:t>
            </a:r>
            <a:r>
              <a:rPr lang="en-US" altLang="ko-KR" sz="1100" kern="100" dirty="0" smtClean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/>
                <a:cs typeface="Times New Roman" panose="02020603050405020304" pitchFamily="18" charset="0"/>
              </a:rPr>
              <a:t>The means not sharing a common letter are significantly different among groups at p &lt; 0.05 by one-way ANOVA with Duncan’s multiple-range test.</a:t>
            </a:r>
            <a:endParaRPr lang="ko-KR" altLang="ko-KR" sz="1100" kern="100" dirty="0">
              <a:solidFill>
                <a:srgbClr val="000000"/>
              </a:solidFill>
              <a:effectLst/>
              <a:latin typeface="바탕" panose="02030600000101010101" pitchFamily="18" charset="-127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38677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91</TotalTime>
  <Words>191</Words>
  <Application>Microsoft Office PowerPoint</Application>
  <PresentationFormat>와이드스크린</PresentationFormat>
  <Paragraphs>3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DengXian</vt:lpstr>
      <vt:lpstr>맑은 고딕</vt:lpstr>
      <vt:lpstr>바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황윤호</dc:creator>
  <cp:lastModifiedBy>Su-Jin Kim</cp:lastModifiedBy>
  <cp:revision>24</cp:revision>
  <dcterms:created xsi:type="dcterms:W3CDTF">2018-08-10T07:11:18Z</dcterms:created>
  <dcterms:modified xsi:type="dcterms:W3CDTF">2018-08-17T13:21:43Z</dcterms:modified>
</cp:coreProperties>
</file>